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png" ContentType="image/png"/>
  <Override PartName="/ppt/media/image4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E7FDF5-36D6-42C6-B900-0A90F53E734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4EA38D-4220-4A53-AA5A-D6F8AAB4690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AD0AA8-A3CD-4E75-99DB-6187D40EC9B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765C53-BBCA-4A3D-91DB-70596CF680C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 rtl="1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F128B7-6B9B-47AA-BA09-41EBB9DDE01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407A344-E71A-4F08-AC36-8728D8D0549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3855FE-A30A-453D-9A3A-6AB4D5B2B33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B24DFC-E500-43F2-AC3F-8018B034D9D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 rtl="1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DE4DF2-B478-4322-9B06-E29965CA86F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3DF012-5C04-4D08-8BEF-36DD78593FD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D74850-014B-490D-9503-7949C34445B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20BD2A-C542-48DF-BD04-579D5D455FF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 algn="r" rtl="1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 algn="r" rtl="1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 rtl="1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he-IL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 rtl="1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he-IL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rtl="1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he-IL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rtl="1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D03CDA6-C042-4FEA-8804-9C164F3FF552}" type="slidenum">
              <a:rPr b="0" lang="he-IL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94"/>
          <p:cNvSpPr/>
          <p:nvPr/>
        </p:nvSpPr>
        <p:spPr>
          <a:xfrm>
            <a:off x="285840" y="4929120"/>
            <a:ext cx="2500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ure S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Picture 2" descr="pop in int 1"/>
          <p:cNvPicPr/>
          <p:nvPr/>
        </p:nvPicPr>
        <p:blipFill>
          <a:blip r:embed="rId1"/>
          <a:srcRect l="0" t="15037" r="11122" b="35404"/>
          <a:stretch/>
        </p:blipFill>
        <p:spPr>
          <a:xfrm>
            <a:off x="1143000" y="1785960"/>
            <a:ext cx="1928880" cy="1500120"/>
          </a:xfrm>
          <a:prstGeom prst="rect">
            <a:avLst/>
          </a:prstGeom>
          <a:ln w="0">
            <a:noFill/>
          </a:ln>
        </p:spPr>
      </p:pic>
      <p:pic>
        <p:nvPicPr>
          <p:cNvPr id="43" name="תמונה 1" descr="C:\Users\Adit\Desktop\work\intein\pcr on pop in int.jpg"/>
          <p:cNvPicPr/>
          <p:nvPr/>
        </p:nvPicPr>
        <p:blipFill>
          <a:blip r:embed="rId2"/>
          <a:srcRect l="6755" t="6988" r="28624" b="48755"/>
          <a:stretch/>
        </p:blipFill>
        <p:spPr>
          <a:xfrm>
            <a:off x="4000680" y="1857240"/>
            <a:ext cx="2643120" cy="1357560"/>
          </a:xfrm>
          <a:prstGeom prst="rect">
            <a:avLst/>
          </a:prstGeom>
          <a:ln w="0">
            <a:noFill/>
          </a:ln>
        </p:spPr>
      </p:pic>
      <p:sp>
        <p:nvSpPr>
          <p:cNvPr id="44" name="Text Box 4"/>
          <p:cNvSpPr/>
          <p:nvPr/>
        </p:nvSpPr>
        <p:spPr>
          <a:xfrm>
            <a:off x="1457280" y="1500120"/>
            <a:ext cx="500040" cy="344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λ</a:t>
            </a:r>
            <a:r>
              <a:rPr b="0" i="1" lang="en-US" sz="800" spc="-1" strike="noStrike">
                <a:solidFill>
                  <a:srgbClr val="000000"/>
                </a:solidFill>
                <a:latin typeface="Arial"/>
              </a:rPr>
              <a:t>Bst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E diges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 Box 4"/>
          <p:cNvSpPr/>
          <p:nvPr/>
        </p:nvSpPr>
        <p:spPr>
          <a:xfrm>
            <a:off x="1738440" y="1571760"/>
            <a:ext cx="357120" cy="285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 Box 4"/>
          <p:cNvSpPr/>
          <p:nvPr/>
        </p:nvSpPr>
        <p:spPr>
          <a:xfrm>
            <a:off x="1947960" y="1571760"/>
            <a:ext cx="357120" cy="285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 Box 4"/>
          <p:cNvSpPr/>
          <p:nvPr/>
        </p:nvSpPr>
        <p:spPr>
          <a:xfrm>
            <a:off x="2157480" y="1571760"/>
            <a:ext cx="357120" cy="285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 Box 4"/>
          <p:cNvSpPr/>
          <p:nvPr/>
        </p:nvSpPr>
        <p:spPr>
          <a:xfrm>
            <a:off x="2367000" y="1571760"/>
            <a:ext cx="357120" cy="285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 Box 4"/>
          <p:cNvSpPr/>
          <p:nvPr/>
        </p:nvSpPr>
        <p:spPr>
          <a:xfrm>
            <a:off x="2576520" y="1571760"/>
            <a:ext cx="357120" cy="285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 Box 4"/>
          <p:cNvSpPr/>
          <p:nvPr/>
        </p:nvSpPr>
        <p:spPr>
          <a:xfrm>
            <a:off x="2786040" y="1571760"/>
            <a:ext cx="357120" cy="285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 Box 4"/>
          <p:cNvSpPr/>
          <p:nvPr/>
        </p:nvSpPr>
        <p:spPr>
          <a:xfrm>
            <a:off x="3786120" y="1549440"/>
            <a:ext cx="561960" cy="344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λ</a:t>
            </a:r>
            <a:r>
              <a:rPr b="0" i="1" lang="en-US" sz="800" spc="-1" strike="noStrike">
                <a:solidFill>
                  <a:srgbClr val="000000"/>
                </a:solidFill>
                <a:latin typeface="Arial"/>
              </a:rPr>
              <a:t>Bst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E diges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 Box 4"/>
          <p:cNvSpPr/>
          <p:nvPr/>
        </p:nvSpPr>
        <p:spPr>
          <a:xfrm>
            <a:off x="4491000" y="1631880"/>
            <a:ext cx="357120" cy="285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 Box 4"/>
          <p:cNvSpPr/>
          <p:nvPr/>
        </p:nvSpPr>
        <p:spPr>
          <a:xfrm>
            <a:off x="4695840" y="1631880"/>
            <a:ext cx="357120" cy="285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 Box 4"/>
          <p:cNvSpPr/>
          <p:nvPr/>
        </p:nvSpPr>
        <p:spPr>
          <a:xfrm>
            <a:off x="4933800" y="1631880"/>
            <a:ext cx="357480" cy="285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 Box 4"/>
          <p:cNvSpPr/>
          <p:nvPr/>
        </p:nvSpPr>
        <p:spPr>
          <a:xfrm>
            <a:off x="6143760" y="1603440"/>
            <a:ext cx="357120" cy="285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 Box 4"/>
          <p:cNvSpPr/>
          <p:nvPr/>
        </p:nvSpPr>
        <p:spPr>
          <a:xfrm>
            <a:off x="6357960" y="1603440"/>
            <a:ext cx="357120" cy="285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Box 31"/>
          <p:cNvSpPr/>
          <p:nvPr/>
        </p:nvSpPr>
        <p:spPr>
          <a:xfrm>
            <a:off x="428760" y="1379520"/>
            <a:ext cx="500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Box 35"/>
          <p:cNvSpPr/>
          <p:nvPr/>
        </p:nvSpPr>
        <p:spPr>
          <a:xfrm>
            <a:off x="3357720" y="1379520"/>
            <a:ext cx="500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סוגר מסולסל שמאלי 36"/>
          <p:cNvSpPr/>
          <p:nvPr/>
        </p:nvSpPr>
        <p:spPr>
          <a:xfrm rot="5400000">
            <a:off x="4786200" y="1293840"/>
            <a:ext cx="214560" cy="642960"/>
          </a:xfrm>
          <a:custGeom>
            <a:avLst/>
            <a:gdLst>
              <a:gd name="textAreaLeft" fmla="*/ 137160 w 214560"/>
              <a:gd name="textAreaRight" fmla="*/ 214920 w 214560"/>
              <a:gd name="textAreaTop" fmla="*/ 5400 h 642960"/>
              <a:gd name="textAreaBottom" fmla="*/ 637560 h 64296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300"/>
                  <a:pt x="10800" y="600"/>
                </a:cubicBezTo>
                <a:lnTo>
                  <a:pt x="10800" y="10200"/>
                </a:lnTo>
                <a:cubicBezTo>
                  <a:pt x="10800" y="10500"/>
                  <a:pt x="5400" y="10800"/>
                  <a:pt x="0" y="10800"/>
                </a:cubicBezTo>
                <a:cubicBezTo>
                  <a:pt x="5400" y="10800"/>
                  <a:pt x="10800" y="11100"/>
                  <a:pt x="10800" y="11400"/>
                </a:cubicBezTo>
                <a:lnTo>
                  <a:pt x="10800" y="21000"/>
                </a:lnTo>
                <a:cubicBezTo>
                  <a:pt x="10800" y="21300"/>
                  <a:pt x="162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 Box 10"/>
          <p:cNvSpPr/>
          <p:nvPr/>
        </p:nvSpPr>
        <p:spPr>
          <a:xfrm>
            <a:off x="4786200" y="1317600"/>
            <a:ext cx="304920" cy="201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I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 Box 11"/>
          <p:cNvSpPr/>
          <p:nvPr/>
        </p:nvSpPr>
        <p:spPr>
          <a:xfrm>
            <a:off x="6215040" y="1317600"/>
            <a:ext cx="304920" cy="201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II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סוגר מסולסל שמאלי 41"/>
          <p:cNvSpPr/>
          <p:nvPr/>
        </p:nvSpPr>
        <p:spPr>
          <a:xfrm rot="5400000">
            <a:off x="6238080" y="1326960"/>
            <a:ext cx="214560" cy="500040"/>
          </a:xfrm>
          <a:custGeom>
            <a:avLst/>
            <a:gdLst>
              <a:gd name="textAreaLeft" fmla="*/ 137160 w 214560"/>
              <a:gd name="textAreaRight" fmla="*/ 214920 w 214560"/>
              <a:gd name="textAreaTop" fmla="*/ 5400 h 500040"/>
              <a:gd name="textAreaBottom" fmla="*/ 494640 h 500040"/>
            </a:gdLst>
            <a:ahLst/>
            <a:rect l="textAreaLeft" t="textAreaTop" r="textAreaRight" b="textAreaBottom"/>
            <a:pathLst>
              <a:path w="21600" h="21600">
                <a:moveTo>
                  <a:pt x="21600" y="0"/>
                </a:moveTo>
                <a:cubicBezTo>
                  <a:pt x="16200" y="0"/>
                  <a:pt x="10800" y="386"/>
                  <a:pt x="10800" y="771"/>
                </a:cubicBezTo>
                <a:lnTo>
                  <a:pt x="10800" y="10029"/>
                </a:lnTo>
                <a:cubicBezTo>
                  <a:pt x="10800" y="10415"/>
                  <a:pt x="5400" y="10800"/>
                  <a:pt x="0" y="10800"/>
                </a:cubicBezTo>
                <a:cubicBezTo>
                  <a:pt x="5400" y="10800"/>
                  <a:pt x="10800" y="11186"/>
                  <a:pt x="10800" y="11571"/>
                </a:cubicBezTo>
                <a:lnTo>
                  <a:pt x="10800" y="20829"/>
                </a:lnTo>
                <a:cubicBezTo>
                  <a:pt x="10800" y="21215"/>
                  <a:pt x="16200" y="21600"/>
                  <a:pt x="21600" y="21600"/>
                </a:cubicBezTo>
              </a:path>
            </a:pathLst>
          </a:cu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3" name="קבוצה 49"/>
          <p:cNvGrpSpPr/>
          <p:nvPr/>
        </p:nvGrpSpPr>
        <p:grpSpPr>
          <a:xfrm>
            <a:off x="1143000" y="3714840"/>
            <a:ext cx="857160" cy="1000080"/>
            <a:chOff x="1143000" y="3714840"/>
            <a:chExt cx="857160" cy="1000080"/>
          </a:xfrm>
        </p:grpSpPr>
        <p:pic>
          <p:nvPicPr>
            <p:cNvPr id="64" name="Picture 36" descr="H:\photos for article\5.7.10-pcr heg.bmp"/>
            <p:cNvPicPr/>
            <p:nvPr/>
          </p:nvPicPr>
          <p:blipFill>
            <a:blip r:embed="rId3"/>
            <a:srcRect l="7511" t="25128" r="87223" b="46610"/>
            <a:stretch/>
          </p:blipFill>
          <p:spPr>
            <a:xfrm>
              <a:off x="1143000" y="3714840"/>
              <a:ext cx="285480" cy="10000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5" name="Picture 36" descr="H:\photos for article\5.7.10-pcr heg.bmp"/>
            <p:cNvPicPr/>
            <p:nvPr/>
          </p:nvPicPr>
          <p:blipFill>
            <a:blip r:embed="rId4"/>
            <a:srcRect l="21069" t="25128" r="69317" b="46610"/>
            <a:stretch/>
          </p:blipFill>
          <p:spPr>
            <a:xfrm>
              <a:off x="1478160" y="3714840"/>
              <a:ext cx="522000" cy="100008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66" name="TextBox 35"/>
          <p:cNvSpPr/>
          <p:nvPr/>
        </p:nvSpPr>
        <p:spPr>
          <a:xfrm>
            <a:off x="428760" y="3365640"/>
            <a:ext cx="500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 Box 4"/>
          <p:cNvSpPr/>
          <p:nvPr/>
        </p:nvSpPr>
        <p:spPr>
          <a:xfrm>
            <a:off x="1066680" y="3403440"/>
            <a:ext cx="500040" cy="344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ts val="7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00 bp ladder plu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Text Box 4"/>
          <p:cNvSpPr/>
          <p:nvPr/>
        </p:nvSpPr>
        <p:spPr>
          <a:xfrm>
            <a:off x="4143240" y="1614600"/>
            <a:ext cx="500040" cy="344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ts val="7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kb ladder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 Box 4"/>
          <p:cNvSpPr/>
          <p:nvPr/>
        </p:nvSpPr>
        <p:spPr>
          <a:xfrm>
            <a:off x="1071720" y="1428840"/>
            <a:ext cx="500040" cy="344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lnSpc>
                <a:spcPts val="7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00 bp ladder plus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 Box 4"/>
          <p:cNvSpPr/>
          <p:nvPr/>
        </p:nvSpPr>
        <p:spPr>
          <a:xfrm>
            <a:off x="1500120" y="3500280"/>
            <a:ext cx="252360" cy="285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 Box 4"/>
          <p:cNvSpPr/>
          <p:nvPr/>
        </p:nvSpPr>
        <p:spPr>
          <a:xfrm>
            <a:off x="1714680" y="3505320"/>
            <a:ext cx="261720" cy="285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Box 20"/>
          <p:cNvSpPr/>
          <p:nvPr/>
        </p:nvSpPr>
        <p:spPr>
          <a:xfrm>
            <a:off x="0" y="2357280"/>
            <a:ext cx="7142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1600bp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73" name="מחבר חץ ישר 39"/>
          <p:cNvCxnSpPr/>
          <p:nvPr/>
        </p:nvCxnSpPr>
        <p:spPr>
          <a:xfrm>
            <a:off x="713880" y="2499840"/>
            <a:ext cx="358200" cy="252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74" name="מחבר חץ ישר 40"/>
          <p:cNvCxnSpPr/>
          <p:nvPr/>
        </p:nvCxnSpPr>
        <p:spPr>
          <a:xfrm>
            <a:off x="713880" y="3855600"/>
            <a:ext cx="358200" cy="252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75" name="מחבר חץ ישר 42"/>
          <p:cNvCxnSpPr/>
          <p:nvPr/>
        </p:nvCxnSpPr>
        <p:spPr>
          <a:xfrm>
            <a:off x="713880" y="4005360"/>
            <a:ext cx="358200" cy="21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76" name="TextBox 20"/>
          <p:cNvSpPr/>
          <p:nvPr/>
        </p:nvSpPr>
        <p:spPr>
          <a:xfrm>
            <a:off x="-71280" y="3714840"/>
            <a:ext cx="7855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3000bp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TextBox 20"/>
          <p:cNvSpPr/>
          <p:nvPr/>
        </p:nvSpPr>
        <p:spPr>
          <a:xfrm>
            <a:off x="-71280" y="3857760"/>
            <a:ext cx="78552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1700bp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Text Box 4"/>
          <p:cNvSpPr/>
          <p:nvPr/>
        </p:nvSpPr>
        <p:spPr>
          <a:xfrm>
            <a:off x="5500800" y="1542960"/>
            <a:ext cx="571320" cy="344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spcAft>
                <a:spcPts val="1001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λ</a:t>
            </a:r>
            <a:r>
              <a:rPr b="0" i="1" lang="en-US" sz="800" spc="-1" strike="noStrike">
                <a:solidFill>
                  <a:srgbClr val="000000"/>
                </a:solidFill>
                <a:latin typeface="Arial"/>
              </a:rPr>
              <a:t>Bst</a:t>
            </a:r>
            <a:r>
              <a:rPr b="0" lang="en-US" sz="800" spc="-1" strike="noStrike">
                <a:solidFill>
                  <a:srgbClr val="000000"/>
                </a:solidFill>
                <a:latin typeface="Arial"/>
              </a:rPr>
              <a:t>E diges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79" name="מחבר חץ ישר 46"/>
          <p:cNvCxnSpPr/>
          <p:nvPr/>
        </p:nvCxnSpPr>
        <p:spPr>
          <a:xfrm>
            <a:off x="3642840" y="2327400"/>
            <a:ext cx="358200" cy="216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cxnSp>
        <p:nvCxnSpPr>
          <p:cNvPr id="80" name="מחבר חץ ישר 47"/>
          <p:cNvCxnSpPr/>
          <p:nvPr/>
        </p:nvCxnSpPr>
        <p:spPr>
          <a:xfrm>
            <a:off x="3642840" y="2476080"/>
            <a:ext cx="358200" cy="2520"/>
          </a:xfrm>
          <a:prstGeom prst="straightConnector1">
            <a:avLst/>
          </a:prstGeom>
          <a:ln w="9360">
            <a:solidFill>
              <a:srgbClr val="000000"/>
            </a:solidFill>
            <a:miter/>
            <a:tailEnd len="med" type="arrow" w="med"/>
          </a:ln>
        </p:spPr>
      </p:cxnSp>
      <p:sp>
        <p:nvSpPr>
          <p:cNvPr id="81" name="TextBox 20"/>
          <p:cNvSpPr/>
          <p:nvPr/>
        </p:nvSpPr>
        <p:spPr>
          <a:xfrm>
            <a:off x="2928960" y="2166840"/>
            <a:ext cx="7858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4200bp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TextBox 20"/>
          <p:cNvSpPr/>
          <p:nvPr/>
        </p:nvSpPr>
        <p:spPr>
          <a:xfrm>
            <a:off x="2928960" y="2347920"/>
            <a:ext cx="7858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3200bp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3" name="תמונה 130" descr="for supp2.png"/>
          <p:cNvPicPr/>
          <p:nvPr/>
        </p:nvPicPr>
        <p:blipFill>
          <a:blip r:embed="rId5"/>
          <a:stretch/>
        </p:blipFill>
        <p:spPr>
          <a:xfrm>
            <a:off x="2428920" y="3538440"/>
            <a:ext cx="4397400" cy="1309680"/>
          </a:xfrm>
          <a:prstGeom prst="rect">
            <a:avLst/>
          </a:prstGeom>
          <a:ln w="0">
            <a:noFill/>
          </a:ln>
        </p:spPr>
      </p:pic>
      <p:sp>
        <p:nvSpPr>
          <p:cNvPr id="84" name="TextBox 35"/>
          <p:cNvSpPr/>
          <p:nvPr/>
        </p:nvSpPr>
        <p:spPr>
          <a:xfrm>
            <a:off x="2130480" y="3365640"/>
            <a:ext cx="5000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11-15T07:02:46Z</dcterms:created>
  <dc:creator>Adit</dc:creator>
  <dc:description/>
  <dc:language>en-US</dc:language>
  <cp:lastModifiedBy>Adit</cp:lastModifiedBy>
  <dcterms:modified xsi:type="dcterms:W3CDTF">2010-12-20T07:21:21Z</dcterms:modified>
  <cp:revision>8</cp:revision>
  <dc:subject/>
  <dc:title>שקופית 1</dc:title>
</cp:coreProperties>
</file>